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154"/>
    <p:restoredTop sz="94694"/>
  </p:normalViewPr>
  <p:slideViewPr>
    <p:cSldViewPr snapToGrid="0" snapToObjects="1">
      <p:cViewPr varScale="1">
        <p:scale>
          <a:sx n="65" d="100"/>
          <a:sy n="65" d="100"/>
        </p:scale>
        <p:origin x="2534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69923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00216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09236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64987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29940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97815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09402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62389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29810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26430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36780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42999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1D314E9C-CFF1-AA45-D79B-B1E6E3D5FE7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5283" t="35603" r="7055" b="31804"/>
          <a:stretch/>
        </p:blipFill>
        <p:spPr>
          <a:xfrm>
            <a:off x="885151" y="3205274"/>
            <a:ext cx="1883820" cy="554064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55F79E7C-F58B-6CE2-9DC9-CB85CBC12CB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80256" y="1384069"/>
            <a:ext cx="1711253" cy="1639490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68844E99-4D3C-47EF-9031-9C8803B34843}"/>
              </a:ext>
            </a:extLst>
          </p:cNvPr>
          <p:cNvSpPr txBox="1"/>
          <p:nvPr/>
        </p:nvSpPr>
        <p:spPr>
          <a:xfrm rot="18900000">
            <a:off x="786500" y="1063878"/>
            <a:ext cx="562975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HUPT3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8726AB0-B5AC-D71A-02C6-CE2B0F37EEB7}"/>
              </a:ext>
            </a:extLst>
          </p:cNvPr>
          <p:cNvSpPr txBox="1"/>
          <p:nvPr/>
        </p:nvSpPr>
        <p:spPr>
          <a:xfrm rot="18900000">
            <a:off x="961215" y="1029834"/>
            <a:ext cx="665567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TU8988T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23FE4E5-6E53-D28D-A4F7-152E4873FC9C}"/>
              </a:ext>
            </a:extLst>
          </p:cNvPr>
          <p:cNvSpPr txBox="1"/>
          <p:nvPr/>
        </p:nvSpPr>
        <p:spPr>
          <a:xfrm rot="18900000">
            <a:off x="1196676" y="1063878"/>
            <a:ext cx="562975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ASPC1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603AD32-3089-E382-C181-AB8B704DC780}"/>
              </a:ext>
            </a:extLst>
          </p:cNvPr>
          <p:cNvSpPr txBox="1"/>
          <p:nvPr/>
        </p:nvSpPr>
        <p:spPr>
          <a:xfrm rot="18900000">
            <a:off x="1400058" y="1078981"/>
            <a:ext cx="518091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DANG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184A75F-6F3B-F707-325A-7246021AD7E6}"/>
              </a:ext>
            </a:extLst>
          </p:cNvPr>
          <p:cNvSpPr txBox="1"/>
          <p:nvPr/>
        </p:nvSpPr>
        <p:spPr>
          <a:xfrm rot="18900000">
            <a:off x="1573539" y="1053330"/>
            <a:ext cx="595035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TU8902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0A067A0-E030-48B5-1B44-01CDB9B62F62}"/>
              </a:ext>
            </a:extLst>
          </p:cNvPr>
          <p:cNvSpPr txBox="1"/>
          <p:nvPr/>
        </p:nvSpPr>
        <p:spPr>
          <a:xfrm rot="18900000">
            <a:off x="1768104" y="1027677"/>
            <a:ext cx="671979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TU8988S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763DAB0-D24B-4E31-45D1-98050EE44069}"/>
              </a:ext>
            </a:extLst>
          </p:cNvPr>
          <p:cNvSpPr txBox="1"/>
          <p:nvPr/>
        </p:nvSpPr>
        <p:spPr>
          <a:xfrm rot="18900000">
            <a:off x="1957560" y="1026209"/>
            <a:ext cx="684803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CAPAN-2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50FE4774-30B8-38A7-89BA-B97B44E99CC9}"/>
              </a:ext>
            </a:extLst>
          </p:cNvPr>
          <p:cNvSpPr txBox="1"/>
          <p:nvPr/>
        </p:nvSpPr>
        <p:spPr>
          <a:xfrm rot="18900000">
            <a:off x="2142823" y="997948"/>
            <a:ext cx="761747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MiaPaCa-2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22637A5-FA9F-6D81-F1B5-F2C85FE261A0}"/>
              </a:ext>
            </a:extLst>
          </p:cNvPr>
          <p:cNvSpPr txBox="1"/>
          <p:nvPr/>
        </p:nvSpPr>
        <p:spPr>
          <a:xfrm>
            <a:off x="357710" y="3361039"/>
            <a:ext cx="588623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09A7880-5FDD-A8E6-DAFB-BD07D44370D0}"/>
              </a:ext>
            </a:extLst>
          </p:cNvPr>
          <p:cNvSpPr txBox="1"/>
          <p:nvPr/>
        </p:nvSpPr>
        <p:spPr>
          <a:xfrm>
            <a:off x="407252" y="2268790"/>
            <a:ext cx="486030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UPP1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584F6633-9FB3-1D8D-DD0E-849D3E7CA962}"/>
              </a:ext>
            </a:extLst>
          </p:cNvPr>
          <p:cNvSpPr/>
          <p:nvPr/>
        </p:nvSpPr>
        <p:spPr>
          <a:xfrm>
            <a:off x="1003725" y="2268791"/>
            <a:ext cx="1527428" cy="197419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>
              <a:solidFill>
                <a:schemeClr val="tx1"/>
              </a:solidFill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7A60793-9141-7402-6E87-B6A6BAE3A5A5}"/>
              </a:ext>
            </a:extLst>
          </p:cNvPr>
          <p:cNvSpPr txBox="1"/>
          <p:nvPr/>
        </p:nvSpPr>
        <p:spPr>
          <a:xfrm>
            <a:off x="2642057" y="1215250"/>
            <a:ext cx="457176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~kD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B1C2E5C-36FE-B2B0-A3EC-9FDE20E16D32}"/>
              </a:ext>
            </a:extLst>
          </p:cNvPr>
          <p:cNvSpPr txBox="1"/>
          <p:nvPr/>
        </p:nvSpPr>
        <p:spPr>
          <a:xfrm>
            <a:off x="2706744" y="2270001"/>
            <a:ext cx="312906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6840147-D5B8-0927-9C69-A4FCF2CA11C4}"/>
              </a:ext>
            </a:extLst>
          </p:cNvPr>
          <p:cNvSpPr txBox="1"/>
          <p:nvPr/>
        </p:nvSpPr>
        <p:spPr>
          <a:xfrm>
            <a:off x="2643386" y="3354998"/>
            <a:ext cx="377026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125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A6D101C-2FDD-2BCC-695A-F6E8C9C073BA}"/>
              </a:ext>
            </a:extLst>
          </p:cNvPr>
          <p:cNvSpPr txBox="1"/>
          <p:nvPr/>
        </p:nvSpPr>
        <p:spPr>
          <a:xfrm>
            <a:off x="209904" y="166613"/>
            <a:ext cx="6434775" cy="3277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3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. </a:t>
            </a:r>
            <a:r>
              <a:rPr lang="en-US" sz="1530" dirty="0">
                <a:latin typeface="Arial" panose="020B0604020202020204" pitchFamily="34" charset="0"/>
                <a:cs typeface="Arial" panose="020B0604020202020204" pitchFamily="34" charset="0"/>
              </a:rPr>
              <a:t>Full, uncropped western image for Figure 1e.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A99FE612-C028-4A21-BC1F-D2D574A69940}"/>
              </a:ext>
            </a:extLst>
          </p:cNvPr>
          <p:cNvSpPr/>
          <p:nvPr/>
        </p:nvSpPr>
        <p:spPr>
          <a:xfrm>
            <a:off x="1015001" y="3362796"/>
            <a:ext cx="1527428" cy="197419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46940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845</TotalTime>
  <Words>27</Words>
  <Application>Microsoft Office PowerPoint</Application>
  <PresentationFormat>Custom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tton, Damien</dc:creator>
  <cp:lastModifiedBy>Lyssiotis, Costas</cp:lastModifiedBy>
  <cp:revision>27</cp:revision>
  <dcterms:created xsi:type="dcterms:W3CDTF">2022-08-08T03:19:06Z</dcterms:created>
  <dcterms:modified xsi:type="dcterms:W3CDTF">2023-03-31T02:44:24Z</dcterms:modified>
</cp:coreProperties>
</file>